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574" y="12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18489-8351-0C5C-823A-8EF325B71F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841191-C1F2-5B4B-662E-CADF559E4F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8C1D52-F879-01B6-8422-BEF0FBEEF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A4C8D8-8F3F-B897-329F-7FF6DC386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C20608-D387-D2F0-0101-1E3546616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4859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B533ED-8EEE-D71C-5189-D600F553B0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B2A430-7909-8F87-0304-0005AE3C55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075095-5798-EDFF-5F33-F93FCBFFDA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6345B3-DB02-2FBF-7B6F-4D4D55EB9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D89439-C9A1-F5B4-618C-BEACE3DB0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749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4177264-3692-B462-A507-614DC04262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88B72E-6196-93ED-B61F-3DA8E741AA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802512-30CF-58D1-75EF-1A97F253C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B0C55A-4CEF-1314-B2AE-F6715F330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2F9C6D-DA20-DB01-DC20-E88F371AD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6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7CF9E0-0974-8031-3107-E7BE45C9CC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B48686-5574-DD17-0856-C15C7A1CC1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F16B44-3EA5-EC3E-2D79-FAEDD6E85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305BCA-2C65-B9B0-8A8B-7DE2684DD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982F15-B0C3-D9A9-2B60-7110500C2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055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479C25-B5A9-7BB2-ACBE-6697A5AEC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F8FE91-E4C4-044B-5412-AD564940EB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362631-F516-0C6B-5965-CB225332C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329D63-D519-CBBB-D8F1-8EEA634AC3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04193F-EE5F-685C-B130-87EBD57CE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4287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7BA5F-68DE-5911-C46B-9C7DC5C290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8CB129-6B18-E74F-DFFB-9576A19556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1FE02C-55DC-4ED7-00E1-DF8121D4FD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642420-C385-254D-807F-90ED0E29A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6DBFA7-661C-AF1F-0849-7214C1287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7C0599-AAA2-1CAE-AC74-EF653C8898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6062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1FD607-73FA-16B7-440B-05A0861D9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0068B7-F49D-E573-6956-F57448F1C6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C8CCF1-4E4B-B606-6A8E-22FBBEB605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573BC6-F0D3-FC20-A18D-7D6D4DB5F1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AB3E3B-51E9-98E0-1AAE-4277082DBB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AE3BAE-4172-6091-9B59-A80DDEA87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F2663D0-9C16-BDFF-7398-7D084C6EF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18564F-B912-0598-EAE0-E4B07B71C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4486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D4D7A3-9B39-3FF1-BB87-1E88C0ABAF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B1EB80-60C8-69F1-F09C-93E0782EA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72993EA-1444-9212-466F-11F825743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7979B45-AC3E-3626-260A-65425FD05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4407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985EADA-7E8A-28BB-433B-9AE479C13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0512192-05FF-9A7C-7A46-EE46CBAB6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7F1798-B49A-7C27-DB00-94EE75019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0544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645761-9443-739E-CA78-6C85A8B2B4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26E367-5149-6C60-F94E-3A8D048696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ADAF5E-C014-6533-836D-DA01CE8FD8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4CDB2B-6154-0663-9A44-EDBD5816A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E09358-A60D-2522-3C00-53C1F6DF3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DE0F76-A3C3-BA48-F343-E8BF15F81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338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D72F8E-E16F-CEA8-B3B0-58AD5492C6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F2BF614-AC4F-6B30-EF8D-FF857519F1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F5212B-D5A3-D802-982D-3EF80E883E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370FAD-C037-448A-877A-6CA99519A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94708A-ED65-467D-9929-4E01CBE49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E24381-3323-BE0D-B7BD-96F82481E2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5041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386E12-9729-9A43-D33E-6B181D9B4F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B85F6E-3456-F95C-F8D4-0067AFD496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18747D-0D55-CF79-3546-34CEB8D8DC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DB0D4D5-B6BA-4A94-82E0-C2F709BB80E4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0D4498-679D-BBE7-FC63-8314059C0F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D566E2-1960-ABA2-C726-09CBDC972C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174DC3-AA9F-452C-9580-0BB0C239BB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9256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FE2641-7EA0-B9D0-4B0C-6E0C8D3F7861}"/>
              </a:ext>
            </a:extLst>
          </p:cNvPr>
          <p:cNvSpPr txBox="1"/>
          <p:nvPr/>
        </p:nvSpPr>
        <p:spPr>
          <a:xfrm>
            <a:off x="224719" y="309451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2BC070B-2177-DE9E-4333-CF7BBA56A7A4}"/>
              </a:ext>
            </a:extLst>
          </p:cNvPr>
          <p:cNvSpPr txBox="1"/>
          <p:nvPr/>
        </p:nvSpPr>
        <p:spPr>
          <a:xfrm>
            <a:off x="2278965" y="410494"/>
            <a:ext cx="880486" cy="3357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 Hr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HX 100 µg/m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05261D7-3B4D-788F-E6BF-53F119503F27}"/>
              </a:ext>
            </a:extLst>
          </p:cNvPr>
          <p:cNvSpPr txBox="1"/>
          <p:nvPr/>
        </p:nvSpPr>
        <p:spPr>
          <a:xfrm>
            <a:off x="805550" y="555511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F6E8F91-5F97-1AD3-0123-0F80647A2ECC}"/>
              </a:ext>
            </a:extLst>
          </p:cNvPr>
          <p:cNvSpPr txBox="1"/>
          <p:nvPr/>
        </p:nvSpPr>
        <p:spPr>
          <a:xfrm>
            <a:off x="932942" y="555511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A4E9161-1F7A-DF44-C880-C883BF6C20A4}"/>
              </a:ext>
            </a:extLst>
          </p:cNvPr>
          <p:cNvSpPr txBox="1"/>
          <p:nvPr/>
        </p:nvSpPr>
        <p:spPr>
          <a:xfrm>
            <a:off x="1105222" y="555511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A13C676-CE57-679D-E9A0-DF6F740A0638}"/>
              </a:ext>
            </a:extLst>
          </p:cNvPr>
          <p:cNvSpPr txBox="1"/>
          <p:nvPr/>
        </p:nvSpPr>
        <p:spPr>
          <a:xfrm>
            <a:off x="1277503" y="555511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C2A6C1E-C61B-316A-23B3-3783513AC4DD}"/>
              </a:ext>
            </a:extLst>
          </p:cNvPr>
          <p:cNvSpPr txBox="1"/>
          <p:nvPr/>
        </p:nvSpPr>
        <p:spPr>
          <a:xfrm>
            <a:off x="1515856" y="555511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D70AD9F-2768-EA25-B354-7E7DDABAAD8E}"/>
              </a:ext>
            </a:extLst>
          </p:cNvPr>
          <p:cNvSpPr txBox="1"/>
          <p:nvPr/>
        </p:nvSpPr>
        <p:spPr>
          <a:xfrm>
            <a:off x="1643248" y="555511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ED7DDBB-0C4A-A593-681D-724C9DEA3240}"/>
              </a:ext>
            </a:extLst>
          </p:cNvPr>
          <p:cNvSpPr txBox="1"/>
          <p:nvPr/>
        </p:nvSpPr>
        <p:spPr>
          <a:xfrm>
            <a:off x="1815529" y="555511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BE847AB-7A73-006F-2CAA-F3F6FDE91635}"/>
              </a:ext>
            </a:extLst>
          </p:cNvPr>
          <p:cNvSpPr txBox="1"/>
          <p:nvPr/>
        </p:nvSpPr>
        <p:spPr>
          <a:xfrm>
            <a:off x="1987810" y="555511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38E1A342-512B-6FF8-365F-C05E128D4584}"/>
              </a:ext>
            </a:extLst>
          </p:cNvPr>
          <p:cNvCxnSpPr>
            <a:cxnSpLocks/>
          </p:cNvCxnSpPr>
          <p:nvPr/>
        </p:nvCxnSpPr>
        <p:spPr>
          <a:xfrm>
            <a:off x="830202" y="555511"/>
            <a:ext cx="62230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432C7161-0ECD-EA57-8C3E-C2BDD10017CF}"/>
              </a:ext>
            </a:extLst>
          </p:cNvPr>
          <p:cNvCxnSpPr>
            <a:cxnSpLocks/>
          </p:cNvCxnSpPr>
          <p:nvPr/>
        </p:nvCxnSpPr>
        <p:spPr>
          <a:xfrm>
            <a:off x="1540510" y="555511"/>
            <a:ext cx="62230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04E97F22-29EC-2DE5-79A8-6C533992A74B}"/>
              </a:ext>
            </a:extLst>
          </p:cNvPr>
          <p:cNvSpPr txBox="1"/>
          <p:nvPr/>
        </p:nvSpPr>
        <p:spPr>
          <a:xfrm>
            <a:off x="811768" y="32944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0576C47-5AD0-CA3C-95DA-CF7D02683CA9}"/>
              </a:ext>
            </a:extLst>
          </p:cNvPr>
          <p:cNvSpPr txBox="1"/>
          <p:nvPr/>
        </p:nvSpPr>
        <p:spPr>
          <a:xfrm>
            <a:off x="1383563" y="336091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gRN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341DD13-6171-94F8-3332-A16302963C8A}"/>
              </a:ext>
            </a:extLst>
          </p:cNvPr>
          <p:cNvSpPr txBox="1"/>
          <p:nvPr/>
        </p:nvSpPr>
        <p:spPr>
          <a:xfrm>
            <a:off x="2264170" y="882985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E5EAA14-2205-207C-7A33-F4F040E4C8A8}"/>
              </a:ext>
            </a:extLst>
          </p:cNvPr>
          <p:cNvSpPr txBox="1"/>
          <p:nvPr/>
        </p:nvSpPr>
        <p:spPr>
          <a:xfrm>
            <a:off x="2264170" y="1313281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189E4D-30D2-7B53-EFD9-41BA71D243CC}"/>
              </a:ext>
            </a:extLst>
          </p:cNvPr>
          <p:cNvSpPr txBox="1"/>
          <p:nvPr/>
        </p:nvSpPr>
        <p:spPr>
          <a:xfrm>
            <a:off x="2264170" y="1721157"/>
            <a:ext cx="50596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F7A82464-381E-302F-6577-F79EA3631A7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791" t="29756" r="17631" b="16351"/>
          <a:stretch/>
        </p:blipFill>
        <p:spPr>
          <a:xfrm rot="16200000">
            <a:off x="1366061" y="659712"/>
            <a:ext cx="368827" cy="14753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198A0C75-0DA9-ECA2-DB96-A0C5B16ED90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011" t="30610" r="33411" b="15497"/>
          <a:stretch/>
        </p:blipFill>
        <p:spPr>
          <a:xfrm rot="16200000">
            <a:off x="1366061" y="1067588"/>
            <a:ext cx="368827" cy="14753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94B6AECE-7D86-1FCB-66F5-5486146554C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767" t="29537" r="28969" b="15986"/>
          <a:stretch/>
        </p:blipFill>
        <p:spPr>
          <a:xfrm rot="16200000">
            <a:off x="1366061" y="251960"/>
            <a:ext cx="368827" cy="14753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47143D8B-4311-8634-37A3-3DF5F808EB50}"/>
              </a:ext>
            </a:extLst>
          </p:cNvPr>
          <p:cNvSpPr txBox="1"/>
          <p:nvPr/>
        </p:nvSpPr>
        <p:spPr>
          <a:xfrm>
            <a:off x="413306" y="561785"/>
            <a:ext cx="35440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BF0ACED-BFE5-B359-91F8-ED2CE37A97C5}"/>
              </a:ext>
            </a:extLst>
          </p:cNvPr>
          <p:cNvSpPr txBox="1"/>
          <p:nvPr/>
        </p:nvSpPr>
        <p:spPr>
          <a:xfrm>
            <a:off x="421936" y="814480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D992A52-629E-7857-3C86-2F228E7160FB}"/>
              </a:ext>
            </a:extLst>
          </p:cNvPr>
          <p:cNvSpPr txBox="1"/>
          <p:nvPr/>
        </p:nvSpPr>
        <p:spPr>
          <a:xfrm>
            <a:off x="470111" y="1318531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ADAE428-2F1D-1FE7-256D-3B6749BB32A0}"/>
              </a:ext>
            </a:extLst>
          </p:cNvPr>
          <p:cNvSpPr txBox="1"/>
          <p:nvPr/>
        </p:nvSpPr>
        <p:spPr>
          <a:xfrm>
            <a:off x="470111" y="1823230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A7F61FD-1835-EE0B-AE80-37E9AB3B2743}"/>
              </a:ext>
            </a:extLst>
          </p:cNvPr>
          <p:cNvSpPr txBox="1"/>
          <p:nvPr/>
        </p:nvSpPr>
        <p:spPr>
          <a:xfrm>
            <a:off x="470111" y="1567366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550F965D-7299-D1E9-211B-4371329E1B3E}"/>
              </a:ext>
            </a:extLst>
          </p:cNvPr>
          <p:cNvCxnSpPr/>
          <p:nvPr/>
        </p:nvCxnSpPr>
        <p:spPr>
          <a:xfrm>
            <a:off x="723391" y="93210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49A5350-3ACF-0FA0-2C92-62EA5E22593E}"/>
              </a:ext>
            </a:extLst>
          </p:cNvPr>
          <p:cNvCxnSpPr/>
          <p:nvPr/>
        </p:nvCxnSpPr>
        <p:spPr>
          <a:xfrm>
            <a:off x="723391" y="142885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73272C27-949B-9D62-967A-2096EAD495C8}"/>
              </a:ext>
            </a:extLst>
          </p:cNvPr>
          <p:cNvCxnSpPr/>
          <p:nvPr/>
        </p:nvCxnSpPr>
        <p:spPr>
          <a:xfrm>
            <a:off x="723391" y="194482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0C4785B9-6C20-DA29-392B-6868B2EF7792}"/>
              </a:ext>
            </a:extLst>
          </p:cNvPr>
          <p:cNvCxnSpPr/>
          <p:nvPr/>
        </p:nvCxnSpPr>
        <p:spPr>
          <a:xfrm>
            <a:off x="727869" y="167969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318D329E-BE25-BBE3-4870-93C6B2EFBC6A}"/>
              </a:ext>
            </a:extLst>
          </p:cNvPr>
          <p:cNvSpPr txBox="1"/>
          <p:nvPr/>
        </p:nvSpPr>
        <p:spPr>
          <a:xfrm>
            <a:off x="2315866" y="2406330"/>
            <a:ext cx="880486" cy="3357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 Hr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HX 100 µg/m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FBE80D6-85F9-AE88-D231-A53DFE5956A9}"/>
              </a:ext>
            </a:extLst>
          </p:cNvPr>
          <p:cNvSpPr txBox="1"/>
          <p:nvPr/>
        </p:nvSpPr>
        <p:spPr>
          <a:xfrm>
            <a:off x="800002" y="2511438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ECDD4A0-E7D8-B301-6F4D-5CD3FD1AC703}"/>
              </a:ext>
            </a:extLst>
          </p:cNvPr>
          <p:cNvSpPr txBox="1"/>
          <p:nvPr/>
        </p:nvSpPr>
        <p:spPr>
          <a:xfrm>
            <a:off x="927394" y="2511438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F334D34-C9C0-CC85-2565-C2EDC6E5BB8F}"/>
              </a:ext>
            </a:extLst>
          </p:cNvPr>
          <p:cNvSpPr txBox="1"/>
          <p:nvPr/>
        </p:nvSpPr>
        <p:spPr>
          <a:xfrm>
            <a:off x="806221" y="229806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6960EAD-495B-FE47-E30B-4CD700296AA8}"/>
              </a:ext>
            </a:extLst>
          </p:cNvPr>
          <p:cNvSpPr txBox="1"/>
          <p:nvPr/>
        </p:nvSpPr>
        <p:spPr>
          <a:xfrm>
            <a:off x="1456225" y="2298068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 O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655B206-8DF9-099D-43B7-F466DEA31CC2}"/>
              </a:ext>
            </a:extLst>
          </p:cNvPr>
          <p:cNvSpPr txBox="1"/>
          <p:nvPr/>
        </p:nvSpPr>
        <p:spPr>
          <a:xfrm>
            <a:off x="1099674" y="2511438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F537480-A61F-41B5-E08E-ACD977F0899F}"/>
              </a:ext>
            </a:extLst>
          </p:cNvPr>
          <p:cNvSpPr txBox="1"/>
          <p:nvPr/>
        </p:nvSpPr>
        <p:spPr>
          <a:xfrm>
            <a:off x="1271955" y="2511438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3524A22-E56E-D6EB-90C9-9A12FF993EF3}"/>
              </a:ext>
            </a:extLst>
          </p:cNvPr>
          <p:cNvSpPr txBox="1"/>
          <p:nvPr/>
        </p:nvSpPr>
        <p:spPr>
          <a:xfrm>
            <a:off x="1510309" y="2511438"/>
            <a:ext cx="22616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C79EBF1-2A01-C46F-0AA5-BDAAC9151F92}"/>
              </a:ext>
            </a:extLst>
          </p:cNvPr>
          <p:cNvSpPr txBox="1"/>
          <p:nvPr/>
        </p:nvSpPr>
        <p:spPr>
          <a:xfrm>
            <a:off x="1637700" y="2511438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19DD0C5-7A36-91F9-255E-A9D39637E003}"/>
              </a:ext>
            </a:extLst>
          </p:cNvPr>
          <p:cNvSpPr txBox="1"/>
          <p:nvPr/>
        </p:nvSpPr>
        <p:spPr>
          <a:xfrm>
            <a:off x="1809981" y="2511438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E5968AE-E551-1BB8-AF21-7E8A18DED6A8}"/>
              </a:ext>
            </a:extLst>
          </p:cNvPr>
          <p:cNvSpPr txBox="1"/>
          <p:nvPr/>
        </p:nvSpPr>
        <p:spPr>
          <a:xfrm>
            <a:off x="1982262" y="2511438"/>
            <a:ext cx="28446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DF8C5C62-6FA9-4675-BAC5-A7E60D775819}"/>
              </a:ext>
            </a:extLst>
          </p:cNvPr>
          <p:cNvCxnSpPr/>
          <p:nvPr/>
        </p:nvCxnSpPr>
        <p:spPr>
          <a:xfrm>
            <a:off x="824655" y="2521413"/>
            <a:ext cx="6223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3233A65-645E-4CC0-2973-F46143F8D2D0}"/>
              </a:ext>
            </a:extLst>
          </p:cNvPr>
          <p:cNvCxnSpPr/>
          <p:nvPr/>
        </p:nvCxnSpPr>
        <p:spPr>
          <a:xfrm>
            <a:off x="1534962" y="2521413"/>
            <a:ext cx="6223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38E1BB16-9BE0-40AD-ADC5-C19FEEFB0E22}"/>
              </a:ext>
            </a:extLst>
          </p:cNvPr>
          <p:cNvSpPr txBox="1"/>
          <p:nvPr/>
        </p:nvSpPr>
        <p:spPr>
          <a:xfrm>
            <a:off x="2258621" y="2838912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1E5B91F-3E9E-C1CA-9319-FCA60AB3B0F8}"/>
              </a:ext>
            </a:extLst>
          </p:cNvPr>
          <p:cNvSpPr txBox="1"/>
          <p:nvPr/>
        </p:nvSpPr>
        <p:spPr>
          <a:xfrm>
            <a:off x="2258621" y="3269208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2191B60-AE48-1EA4-B6DC-89CE7335E8E0}"/>
              </a:ext>
            </a:extLst>
          </p:cNvPr>
          <p:cNvSpPr txBox="1"/>
          <p:nvPr/>
        </p:nvSpPr>
        <p:spPr>
          <a:xfrm>
            <a:off x="2258621" y="3677084"/>
            <a:ext cx="49576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5E30C65F-E22F-EB66-2DB3-2205AA5A377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892" t="19948" r="33906" b="51684"/>
          <a:stretch/>
        </p:blipFill>
        <p:spPr>
          <a:xfrm rot="5400000">
            <a:off x="1362047" y="3023394"/>
            <a:ext cx="368827" cy="14753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D33F7F37-157B-E933-8286-E54F7218DA8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84" t="18102" r="48799" b="53450"/>
          <a:stretch/>
        </p:blipFill>
        <p:spPr>
          <a:xfrm rot="5400000">
            <a:off x="1362047" y="2609143"/>
            <a:ext cx="368827" cy="14753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D4EFBDF4-440E-DAC6-424D-BAEAE59B8DF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56" t="12239" r="49125" b="58993"/>
          <a:stretch/>
        </p:blipFill>
        <p:spPr>
          <a:xfrm rot="16200000">
            <a:off x="1362047" y="2204788"/>
            <a:ext cx="368827" cy="14753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BF70A423-B26D-E4A6-9ED5-342F61120AEA}"/>
              </a:ext>
            </a:extLst>
          </p:cNvPr>
          <p:cNvSpPr txBox="1"/>
          <p:nvPr/>
        </p:nvSpPr>
        <p:spPr>
          <a:xfrm>
            <a:off x="401248" y="2525268"/>
            <a:ext cx="35440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79CFE78-73D1-B277-B2EB-9BC02744FF14}"/>
              </a:ext>
            </a:extLst>
          </p:cNvPr>
          <p:cNvSpPr txBox="1"/>
          <p:nvPr/>
        </p:nvSpPr>
        <p:spPr>
          <a:xfrm>
            <a:off x="409878" y="2777963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2EF999E-6D64-4274-864E-E4D87D0BFC80}"/>
              </a:ext>
            </a:extLst>
          </p:cNvPr>
          <p:cNvSpPr txBox="1"/>
          <p:nvPr/>
        </p:nvSpPr>
        <p:spPr>
          <a:xfrm>
            <a:off x="458053" y="3282014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B69E158-833C-B5B3-D06D-C06D48D81D27}"/>
              </a:ext>
            </a:extLst>
          </p:cNvPr>
          <p:cNvSpPr txBox="1"/>
          <p:nvPr/>
        </p:nvSpPr>
        <p:spPr>
          <a:xfrm>
            <a:off x="458053" y="3786713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929F6CE-7953-2B0C-F85F-CA9813EA8304}"/>
              </a:ext>
            </a:extLst>
          </p:cNvPr>
          <p:cNvSpPr txBox="1"/>
          <p:nvPr/>
        </p:nvSpPr>
        <p:spPr>
          <a:xfrm>
            <a:off x="458053" y="3530849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CE85AEAB-9F3C-9DF1-8895-72A4247AFD32}"/>
              </a:ext>
            </a:extLst>
          </p:cNvPr>
          <p:cNvCxnSpPr/>
          <p:nvPr/>
        </p:nvCxnSpPr>
        <p:spPr>
          <a:xfrm>
            <a:off x="711333" y="289559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D08FC7EC-AB7E-E79B-B6AC-7753C7A47E64}"/>
              </a:ext>
            </a:extLst>
          </p:cNvPr>
          <p:cNvCxnSpPr/>
          <p:nvPr/>
        </p:nvCxnSpPr>
        <p:spPr>
          <a:xfrm>
            <a:off x="711333" y="339233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3B205D6E-B19F-E3CD-74D7-22B3EE2AD540}"/>
              </a:ext>
            </a:extLst>
          </p:cNvPr>
          <p:cNvCxnSpPr/>
          <p:nvPr/>
        </p:nvCxnSpPr>
        <p:spPr>
          <a:xfrm>
            <a:off x="711333" y="390830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A89A1544-A726-C481-E9EA-2209F1A13FD1}"/>
              </a:ext>
            </a:extLst>
          </p:cNvPr>
          <p:cNvCxnSpPr/>
          <p:nvPr/>
        </p:nvCxnSpPr>
        <p:spPr>
          <a:xfrm>
            <a:off x="715811" y="364317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1AE92502-A6BB-0F4C-BEBA-6F6866B4F184}"/>
              </a:ext>
            </a:extLst>
          </p:cNvPr>
          <p:cNvSpPr txBox="1"/>
          <p:nvPr/>
        </p:nvSpPr>
        <p:spPr>
          <a:xfrm>
            <a:off x="224719" y="2290719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676BE52-07C4-EF59-5072-59D2E8D690FF}"/>
              </a:ext>
            </a:extLst>
          </p:cNvPr>
          <p:cNvSpPr txBox="1"/>
          <p:nvPr/>
        </p:nvSpPr>
        <p:spPr>
          <a:xfrm>
            <a:off x="709386" y="1992947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DA15EAB-E4AB-D44A-6651-C9682F5E0447}"/>
              </a:ext>
            </a:extLst>
          </p:cNvPr>
          <p:cNvSpPr txBox="1"/>
          <p:nvPr/>
        </p:nvSpPr>
        <p:spPr>
          <a:xfrm>
            <a:off x="746378" y="3960140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id="{3D45B845-6ACC-6B0F-527F-55993C6CDC6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" t="-828" r="-806" b="1786"/>
          <a:stretch/>
        </p:blipFill>
        <p:spPr>
          <a:xfrm rot="16200000">
            <a:off x="3049634" y="824805"/>
            <a:ext cx="3064793" cy="18319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1CB463D9-B519-E2E6-411F-B5D252D9C8A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83" t="2705" r="180" b="597"/>
          <a:stretch/>
        </p:blipFill>
        <p:spPr>
          <a:xfrm rot="16200000">
            <a:off x="5042526" y="766231"/>
            <a:ext cx="2936858" cy="18079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89F24B25-C6E5-CAB0-0509-EDD33417194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" t="-189" r="290" b="805"/>
          <a:stretch/>
        </p:blipFill>
        <p:spPr>
          <a:xfrm rot="16200000">
            <a:off x="3563700" y="2757165"/>
            <a:ext cx="2192649" cy="34811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82F1DFD1-A6D9-EA8A-0961-B865AF1E40C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3" t="689" r="571" b="1673"/>
          <a:stretch/>
        </p:blipFill>
        <p:spPr>
          <a:xfrm rot="5400000">
            <a:off x="6688346" y="3133356"/>
            <a:ext cx="3031592" cy="34584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DC65985C-D00C-21BB-E3B0-4C491EE2AE2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34" t="138" r="1849" b="415"/>
          <a:stretch/>
        </p:blipFill>
        <p:spPr>
          <a:xfrm rot="5400000">
            <a:off x="8505981" y="-39268"/>
            <a:ext cx="3037108" cy="35324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2" name="Rectangle 71">
            <a:extLst>
              <a:ext uri="{FF2B5EF4-FFF2-40B4-BE49-F238E27FC236}">
                <a16:creationId xmlns:a16="http://schemas.microsoft.com/office/drawing/2014/main" id="{97345194-1AAA-3C97-C721-8678982D052E}"/>
              </a:ext>
            </a:extLst>
          </p:cNvPr>
          <p:cNvSpPr/>
          <p:nvPr/>
        </p:nvSpPr>
        <p:spPr>
          <a:xfrm>
            <a:off x="4204069" y="1092832"/>
            <a:ext cx="1185819" cy="3360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308FDEAB-DA08-C72C-7C67-9972FC4CD421}"/>
              </a:ext>
            </a:extLst>
          </p:cNvPr>
          <p:cNvSpPr/>
          <p:nvPr/>
        </p:nvSpPr>
        <p:spPr>
          <a:xfrm>
            <a:off x="6047598" y="714974"/>
            <a:ext cx="1185819" cy="3360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9737D26B-8E69-7D71-3960-124C51F9F14B}"/>
              </a:ext>
            </a:extLst>
          </p:cNvPr>
          <p:cNvSpPr/>
          <p:nvPr/>
        </p:nvSpPr>
        <p:spPr>
          <a:xfrm>
            <a:off x="6057905" y="1152887"/>
            <a:ext cx="1185819" cy="3360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90373975-FD9A-622F-5ED6-F367232E146F}"/>
              </a:ext>
            </a:extLst>
          </p:cNvPr>
          <p:cNvSpPr/>
          <p:nvPr/>
        </p:nvSpPr>
        <p:spPr>
          <a:xfrm>
            <a:off x="10023417" y="1999110"/>
            <a:ext cx="1185819" cy="3360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43B62252-E119-E7DE-5D5A-7E2D055126B2}"/>
              </a:ext>
            </a:extLst>
          </p:cNvPr>
          <p:cNvSpPr/>
          <p:nvPr/>
        </p:nvSpPr>
        <p:spPr>
          <a:xfrm>
            <a:off x="3330637" y="4475078"/>
            <a:ext cx="1088964" cy="3360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670F1916-FECD-0DF4-BC5E-11936FBB5D77}"/>
              </a:ext>
            </a:extLst>
          </p:cNvPr>
          <p:cNvSpPr/>
          <p:nvPr/>
        </p:nvSpPr>
        <p:spPr>
          <a:xfrm>
            <a:off x="8258317" y="4694582"/>
            <a:ext cx="1088964" cy="3360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6E6D7E5-4FC7-4B46-E27F-3CA683BDC21F}"/>
              </a:ext>
            </a:extLst>
          </p:cNvPr>
          <p:cNvSpPr txBox="1"/>
          <p:nvPr/>
        </p:nvSpPr>
        <p:spPr>
          <a:xfrm>
            <a:off x="4572824" y="901193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C927452-6619-C045-FC1F-143F123960E5}"/>
              </a:ext>
            </a:extLst>
          </p:cNvPr>
          <p:cNvSpPr txBox="1"/>
          <p:nvPr/>
        </p:nvSpPr>
        <p:spPr>
          <a:xfrm>
            <a:off x="7414950" y="810975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1EC046C-D108-D31D-647A-6BE3DC7F81BD}"/>
              </a:ext>
            </a:extLst>
          </p:cNvPr>
          <p:cNvSpPr txBox="1"/>
          <p:nvPr/>
        </p:nvSpPr>
        <p:spPr>
          <a:xfrm>
            <a:off x="7397577" y="1228964"/>
            <a:ext cx="50596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D0486B8C-5309-53A8-9673-1C0AADE480CF}"/>
              </a:ext>
            </a:extLst>
          </p:cNvPr>
          <p:cNvSpPr txBox="1"/>
          <p:nvPr/>
        </p:nvSpPr>
        <p:spPr>
          <a:xfrm>
            <a:off x="2353888" y="4597570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6F115BB-66FD-AEAE-38AE-6ED000A05801}"/>
              </a:ext>
            </a:extLst>
          </p:cNvPr>
          <p:cNvSpPr txBox="1"/>
          <p:nvPr/>
        </p:nvSpPr>
        <p:spPr>
          <a:xfrm>
            <a:off x="11247011" y="2014171"/>
            <a:ext cx="50596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0A566BE-E02E-FA97-E37E-781BC79490FC}"/>
              </a:ext>
            </a:extLst>
          </p:cNvPr>
          <p:cNvSpPr txBox="1"/>
          <p:nvPr/>
        </p:nvSpPr>
        <p:spPr>
          <a:xfrm>
            <a:off x="9933379" y="4757668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5009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8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1</cp:revision>
  <dcterms:created xsi:type="dcterms:W3CDTF">2024-05-10T10:13:26Z</dcterms:created>
  <dcterms:modified xsi:type="dcterms:W3CDTF">2024-05-10T10:17:23Z</dcterms:modified>
</cp:coreProperties>
</file>